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4" r:id="rId3"/>
    <p:sldId id="268" r:id="rId4"/>
    <p:sldId id="266" r:id="rId5"/>
    <p:sldId id="265" r:id="rId6"/>
    <p:sldId id="257" r:id="rId7"/>
    <p:sldId id="263" r:id="rId8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1" autoAdjust="0"/>
    <p:restoredTop sz="94675" autoAdjust="0"/>
  </p:normalViewPr>
  <p:slideViewPr>
    <p:cSldViewPr>
      <p:cViewPr>
        <p:scale>
          <a:sx n="96" d="100"/>
          <a:sy n="96" d="100"/>
        </p:scale>
        <p:origin x="-1344" y="-24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ru-R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3293173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969520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1225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956329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50492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20258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30279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81539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84460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6573908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41051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ru-R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ru-R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97B02-F53D-455D-BEB5-199221DBE594}" type="datetimeFigureOut">
              <a:rPr lang="ru-RU" smtClean="0"/>
              <a:t>02.09.2022</a:t>
            </a:fld>
            <a:endParaRPr lang="ru-R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04F0B6-BAE4-4EA7-8017-420C1D46D061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55044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emf"/><Relationship Id="rId4" Type="http://schemas.openxmlformats.org/officeDocument/2006/relationships/package" Target="../embeddings/Microsoft_Excel_Worksheet1.xlsx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pPr algn="just"/>
            <a:r>
              <a:rPr lang="en-US" sz="1800" dirty="0" smtClean="0"/>
              <a:t/>
            </a:r>
            <a:br>
              <a:rPr lang="en-US" sz="1800" dirty="0" smtClean="0"/>
            </a:br>
            <a:r>
              <a:rPr lang="en-US" sz="1800" dirty="0"/>
              <a:t/>
            </a:r>
            <a:br>
              <a:rPr lang="en-US" sz="1800" dirty="0"/>
            </a:br>
            <a:r>
              <a:rPr lang="en-US" sz="1800" dirty="0" smtClean="0"/>
              <a:t/>
            </a:r>
            <a:br>
              <a:rPr lang="en-US" sz="1800" dirty="0" smtClean="0"/>
            </a:br>
            <a:r>
              <a:rPr lang="en-US" sz="1800" b="1" dirty="0" smtClean="0"/>
              <a:t>Supplementary file Figure 1</a:t>
            </a:r>
            <a:r>
              <a:rPr lang="en-US" sz="1800" dirty="0" smtClean="0"/>
              <a:t>. Principal coordinate analysis (</a:t>
            </a:r>
            <a:r>
              <a:rPr lang="en-US" sz="1800" dirty="0" err="1" smtClean="0"/>
              <a:t>PCoA</a:t>
            </a:r>
            <a:r>
              <a:rPr lang="en-US" sz="1800" dirty="0" smtClean="0"/>
              <a:t>) plot in different axis: a- PCoA1 (Axis 1) and PCoA2 (Axis 2) respectively explained 70.96 and 4.03% of the variance of the abundance of gut microbiota at the OTU level; b- PCoA1 (Axis 1) and PCoA3 (Axis 3) respectively explained 70.96 and 3.73% of the variance of the abundance of gut microbiota at the OTU level; c- PCoA2 (Axis 2) and PCoA3 (Axis 3) respectively explained 4.03 and 3.73% of the variance of the abundance of gut microbiota at the OTU level.</a:t>
            </a:r>
            <a:endParaRPr lang="ru-RU" sz="1800" dirty="0"/>
          </a:p>
        </p:txBody>
      </p:sp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121" y="2420888"/>
            <a:ext cx="8441679" cy="2813893"/>
          </a:xfrm>
        </p:spPr>
      </p:pic>
    </p:spTree>
    <p:extLst>
      <p:ext uri="{BB962C8B-B14F-4D97-AF65-F5344CB8AC3E}">
        <p14:creationId xmlns:p14="http://schemas.microsoft.com/office/powerpoint/2010/main" val="40679295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</a:t>
            </a:r>
            <a:r>
              <a:rPr lang="en-US" sz="1800" b="1" dirty="0"/>
              <a:t>1a. </a:t>
            </a:r>
            <a:r>
              <a:rPr lang="en-US" sz="1800" b="1" dirty="0" smtClean="0"/>
              <a:t>Bacterial </a:t>
            </a:r>
            <a:r>
              <a:rPr lang="en-US" sz="1800" b="1" dirty="0"/>
              <a:t>taxa in patients with a confirmed diagnosis versus controls at </a:t>
            </a:r>
            <a:r>
              <a:rPr lang="en-US" sz="1800" b="1" dirty="0" smtClean="0"/>
              <a:t>phylum level.</a:t>
            </a:r>
            <a:endParaRPr lang="ru-RU" sz="18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65539906"/>
              </p:ext>
            </p:extLst>
          </p:nvPr>
        </p:nvGraphicFramePr>
        <p:xfrm>
          <a:off x="683568" y="1844824"/>
          <a:ext cx="7848872" cy="331236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830304"/>
                <a:gridCol w="1566476"/>
                <a:gridCol w="1434563"/>
                <a:gridCol w="1582966"/>
                <a:gridCol w="1434563"/>
              </a:tblGrid>
              <a:tr h="71119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Characteristic**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Overall**, N = 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Normal controls**, N = 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AD**, N = 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p-value**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71119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Acidobacterio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1,130.5 (205.5, 2,913.2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73.0 (146.5, 1,968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,752.0 (316.0, 4,078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&lt;0.001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71119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Verrucomicrobio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17.5 (157.2, 679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23.0 (140.5, 375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500.0 (183.0, 1,351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15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29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Synergisto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.5 (1.0, 11.2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.0 (0.0, 6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6.0 (3.0, 15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03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29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Zixibacter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2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4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68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39292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Planctomycetot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4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8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 dirty="0">
                          <a:effectLst/>
                        </a:rPr>
                        <a:t>0.029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0189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1b. Bacterial </a:t>
            </a:r>
            <a:r>
              <a:rPr lang="en-US" sz="1800" b="1" dirty="0"/>
              <a:t>taxa in patients with a confirmed diagnosis versus controls at </a:t>
            </a:r>
            <a:r>
              <a:rPr lang="en-US" sz="1800" b="1" dirty="0" smtClean="0"/>
              <a:t>class level</a:t>
            </a:r>
            <a:endParaRPr lang="ru-RU" sz="18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5312184"/>
              </p:ext>
            </p:extLst>
          </p:nvPr>
        </p:nvGraphicFramePr>
        <p:xfrm>
          <a:off x="539552" y="1340767"/>
          <a:ext cx="8136904" cy="38884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159119"/>
                <a:gridCol w="1249881"/>
                <a:gridCol w="1405663"/>
                <a:gridCol w="1119458"/>
                <a:gridCol w="1202783"/>
              </a:tblGrid>
              <a:tr h="447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Characteristic**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Overall**, N = 8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Normal controls**, N = 4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AD**, N = 4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**p-value**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47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Acidobacteriota| c_Blastocatell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548.5 (113.0, 1,045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192.0 (74.0, 657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939.0 (265.0, 1,594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&lt;0.001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4704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Synergistota| c_Synergist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.5 (1.0, 11.2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.0 (0.0, 6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6.0 (3.0, 15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03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4704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Planctomycetota| c_Phycisphaera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2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04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47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Verrucomicrobiota| c_Verrucomicrobia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95.0 (150.5, 666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20.0 (130.5, 371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460.0 (171.0, 1,274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14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66454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Actinobacteriota| c_Actinobacter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,146.0 (1,291.0, 6,578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,925.0 (1,709.5, 8,333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2,632.0 (1,162.0, 4,201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16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4704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Firmicutes| c_Incertae Sed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4.0 (2.0, 9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3.0 (1.0, 7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5.0 (2.0, 14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16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24704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Planctomycetota| c_Pla4 lineag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3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6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32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47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Actinobacteriota| c_Acidimicrobiia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538.5 (26.8, 1,212.8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434.0 (24.0, 768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624.0 (29.0, 1,539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35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447145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p_Latescibacterota| c_uncultured soil bacterium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2.2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0.5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>
                          <a:effectLst/>
                        </a:rPr>
                        <a:t>0.0 (0.0, 6.0)</a:t>
                      </a:r>
                      <a:endParaRPr lang="ru-RU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1100" u="none" strike="noStrike" dirty="0">
                          <a:effectLst/>
                        </a:rPr>
                        <a:t>0.044</a:t>
                      </a:r>
                      <a:endParaRPr lang="ru-RU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1345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1c. Bacterial </a:t>
            </a:r>
            <a:r>
              <a:rPr lang="en-US" sz="1800" b="1" dirty="0"/>
              <a:t>taxa in patients with a confirmed diagnosis versus controls at </a:t>
            </a:r>
            <a:r>
              <a:rPr lang="en-US" sz="1800" b="1" dirty="0" smtClean="0"/>
              <a:t>genus level. </a:t>
            </a:r>
            <a:endParaRPr lang="ru-RU" sz="18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4180497"/>
              </p:ext>
            </p:extLst>
          </p:nvPr>
        </p:nvGraphicFramePr>
        <p:xfrm>
          <a:off x="611560" y="1052736"/>
          <a:ext cx="8136903" cy="561662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3022178"/>
                <a:gridCol w="1368338"/>
                <a:gridCol w="1504125"/>
                <a:gridCol w="1406636"/>
                <a:gridCol w="835626"/>
              </a:tblGrid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>
                          <a:effectLst/>
                        </a:rPr>
                        <a:t>**Characteristic**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**Overall**, N = 84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**Normal controls**, N = 4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**AD**, N = 4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**p-value**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Lactobacillaceae</a:t>
                      </a:r>
                      <a:r>
                        <a:rPr lang="en-US" sz="700" u="none" strike="noStrike" dirty="0">
                          <a:effectLst/>
                        </a:rPr>
                        <a:t>| </a:t>
                      </a:r>
                      <a:r>
                        <a:rPr lang="en-US" sz="700" u="none" strike="noStrike" dirty="0" err="1">
                          <a:effectLst/>
                        </a:rPr>
                        <a:t>g_Latilactobacill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4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&lt;0.00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>
                          <a:effectLst/>
                        </a:rPr>
                        <a:t>F_UCG-010| </a:t>
                      </a:r>
                      <a:r>
                        <a:rPr lang="en-US" sz="700" u="none" strike="noStrike" dirty="0" err="1">
                          <a:effectLst/>
                        </a:rPr>
                        <a:t>g_uncultured</a:t>
                      </a:r>
                      <a:r>
                        <a:rPr lang="en-US" sz="700" u="none" strike="noStrike" dirty="0">
                          <a:effectLst/>
                        </a:rPr>
                        <a:t> organism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3.5 (1.0, 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0 (1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6.0 (3.0, 8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&lt;0.00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Butyricicoccaceae</a:t>
                      </a:r>
                      <a:r>
                        <a:rPr lang="en-US" sz="700" u="none" strike="noStrike" dirty="0">
                          <a:effectLst/>
                        </a:rPr>
                        <a:t>| g_UCG-00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8.0 (3.8, 15.2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8.0 (4.0, 14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8.0 (2.0, 2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&gt;0.999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Oscillospiraceae</a:t>
                      </a:r>
                      <a:r>
                        <a:rPr lang="en-US" sz="700" u="none" strike="noStrike" dirty="0">
                          <a:effectLst/>
                        </a:rPr>
                        <a:t>| g_UCG-00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7.0 (2.0, 17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8.0 (3.0, 1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7.0 (2.0, 17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&gt;0.999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Alcaligenaceae</a:t>
                      </a:r>
                      <a:r>
                        <a:rPr lang="en-US" sz="700" u="none" strike="noStrike" dirty="0">
                          <a:effectLst/>
                        </a:rPr>
                        <a:t>| </a:t>
                      </a:r>
                      <a:r>
                        <a:rPr lang="en-US" sz="700" u="none" strike="noStrike" dirty="0" err="1">
                          <a:effectLst/>
                        </a:rPr>
                        <a:t>g_Castellaniell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2.0 (0.0, 7.2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5.0 (0.0, 20.5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Monoglobaceae</a:t>
                      </a:r>
                      <a:r>
                        <a:rPr lang="en-US" sz="700" u="none" strike="noStrike" dirty="0">
                          <a:effectLst/>
                        </a:rPr>
                        <a:t>| </a:t>
                      </a:r>
                      <a:r>
                        <a:rPr lang="en-US" sz="700" u="none" strike="noStrike" dirty="0" err="1">
                          <a:effectLst/>
                        </a:rPr>
                        <a:t>g_Monoglobus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59.5 (114.0, 228.8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186.0 (149.0, 269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38.0 (83.0, 197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Oxalobacteraceae| g_Oxalobacte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7.0 (3.8, 13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4.0 (2.0, 10.5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9.0 (6.0, 1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Synergistaceae| g_Cloacibacillu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3.5 (1.0, 11.2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0 (0.0, 6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6.0 (3.0, 1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3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achnospiraceae| g_Tyzzerell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23.0 (7.5, 51.2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42.0 (16.0, 55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7.0 (4.0, 3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4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omamonadaceae| g_Polaromona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0.0 (0.0, 2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0.0 (0.0, 0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4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Sphingobacteriaceae</a:t>
                      </a:r>
                      <a:r>
                        <a:rPr lang="en-US" sz="700" u="none" strike="noStrike" dirty="0">
                          <a:effectLst/>
                        </a:rPr>
                        <a:t>| </a:t>
                      </a:r>
                      <a:r>
                        <a:rPr lang="en-US" sz="700" u="none" strike="noStrike" dirty="0" err="1">
                          <a:effectLst/>
                        </a:rPr>
                        <a:t>g_Solitale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6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Erysipelatoclostridiaceae| g_Erysipelotrichaceae UCG-003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0.0 (2.0, 50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17.0 (6.0, 55.0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4.0 (1.0, 3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7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 dirty="0" err="1">
                          <a:effectLst/>
                        </a:rPr>
                        <a:t>F_Veillonellaceae</a:t>
                      </a:r>
                      <a:r>
                        <a:rPr lang="en-US" sz="700" u="none" strike="noStrike" dirty="0">
                          <a:effectLst/>
                        </a:rPr>
                        <a:t>| </a:t>
                      </a:r>
                      <a:r>
                        <a:rPr lang="en-US" sz="700" u="none" strike="noStrike" dirty="0" err="1">
                          <a:effectLst/>
                        </a:rPr>
                        <a:t>g_Veillonella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5.5 (6.0, 31.2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26.0 (8.5, 55.5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9.0 (5.0, 2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08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achnospiraceae| g_Roseburi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348.5 (240.0, 559.2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423.0 (298.5, 567.5)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74.0 (199.0, 449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0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[Eubacterium] coprostanoligenes group| g_gut metagenom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450.5 (224.5, 694.2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498.0 (382.0, 851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387.0 (195.0, 52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Eubacteriaceae| g_Eu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0 (0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Rhizobiaceae| g_Phyllo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5 (0.0, 6.2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4.0 (1.0, 9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hitinophagaceae| g_Parasegetibacte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3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actobacillaceae| g_Lactiplantibacillu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5.0 (0.0, 2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1.0 (1.0, 8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0 (0.0, 1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7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ongimicrobiaceae| g_Longimicrob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8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orynebacteriaceae| g_Coryne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18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Akkermansiaceae| g_Akkermansi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40.5 (103.0, 63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76.0 (66.0, 367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99.0 (136.0, 1,109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0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Bifidobacteriaceae| g_Bifido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,804.5 (543.5, 4,051.8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,280.0 (810.0, 4,833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,529.0 (465.0, 2,74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0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TRA3-20| g_metagenom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Vicinamibacteraceae| g_Vicinamibacte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hitinophagaceae| g_UTBCD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4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5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[Eubacterium] coprostanoligenes group| g_uncultured Clostridia 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9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6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Methylophilaceae| g_MM2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6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Methylomirabilaceae| g_MIZ17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29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Pasteurellaceae| g_Haemophilu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8.5 (4.0, 2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2.0 (5.0, 29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7.0 (3.0, 1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0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omamonadaceae| g_Delfti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0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actobacillaceae| g_Levilactobacillu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6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Lachnospiraceae| g_Lachnospiraceae UCG-001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1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Nitrosococcaceae| g_Nitrosococcus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1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hitinophagaceae| g_Niastell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5.2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9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3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hitinophagaceae| g_Dinghuibacte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39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Ectothiorhodospiraceae| g_Thioalkalivibrio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42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NA| g_metagenome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3.0 (1.0, 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4.0 (2.0, 6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.0 (1.0, 5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43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Prevotellaceae| g_Prevotell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06.5 (32.8, 505.8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96.0 (20.5, 448.5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275.0 (84.0, 57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45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Methylophilaceae| g_Methylotenera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1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2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45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208879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Chthoniobacteraceae| g_Candidatus Udaeobacter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3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46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  <a:tr h="115402"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u="none" strike="noStrike">
                          <a:effectLst/>
                        </a:rPr>
                        <a:t>F_Flavobacteriaceae| g_Flavobacterium</a:t>
                      </a:r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3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0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>
                          <a:effectLst/>
                        </a:rPr>
                        <a:t>0.0 (0.0, 37.0)</a:t>
                      </a:r>
                      <a:endParaRPr lang="ru-RU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700" u="none" strike="noStrike" dirty="0">
                          <a:effectLst/>
                        </a:rPr>
                        <a:t>0.047</a:t>
                      </a:r>
                      <a:endParaRPr lang="ru-RU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4650" marR="4650" marT="465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1468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</a:t>
            </a:r>
            <a:r>
              <a:rPr lang="en-US" sz="1800" b="1" dirty="0"/>
              <a:t>2</a:t>
            </a:r>
            <a:r>
              <a:rPr lang="en-US" sz="1800" b="1" dirty="0" smtClean="0"/>
              <a:t>. </a:t>
            </a:r>
            <a:r>
              <a:rPr lang="en-US" sz="1800" dirty="0" smtClean="0"/>
              <a:t>Analysis </a:t>
            </a:r>
            <a:r>
              <a:rPr lang="en-US" sz="1800" dirty="0"/>
              <a:t>of </a:t>
            </a:r>
            <a:r>
              <a:rPr lang="ru-RU" sz="1800" dirty="0"/>
              <a:t>α</a:t>
            </a:r>
            <a:r>
              <a:rPr lang="en-US" sz="1800" dirty="0"/>
              <a:t>-diversity using Shannon, Simpson, Chao1, Observed, ACE, and </a:t>
            </a:r>
            <a:r>
              <a:rPr lang="en-US" sz="1800" dirty="0" smtClean="0"/>
              <a:t>Fisher indices</a:t>
            </a:r>
            <a:endParaRPr lang="ru-RU" sz="1800" dirty="0"/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4115886"/>
              </p:ext>
            </p:extLst>
          </p:nvPr>
        </p:nvGraphicFramePr>
        <p:xfrm>
          <a:off x="611561" y="1412780"/>
          <a:ext cx="7704854" cy="4176457"/>
        </p:xfrm>
        <a:graphic>
          <a:graphicData uri="http://schemas.openxmlformats.org/drawingml/2006/table">
            <a:tbl>
              <a:tblPr firstRow="1" firstCol="1" bandRow="1"/>
              <a:tblGrid>
                <a:gridCol w="1925786"/>
                <a:gridCol w="1925786"/>
                <a:gridCol w="1926641"/>
                <a:gridCol w="1926641"/>
              </a:tblGrid>
              <a:tr h="736207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lpha diversity</a:t>
                      </a:r>
                      <a:endParaRPr lang="ru-RU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Normal controls, </a:t>
                      </a:r>
                      <a:endParaRPr lang="ru-RU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N = 43</a:t>
                      </a:r>
                      <a:r>
                        <a:rPr lang="en-US" sz="1100" b="1" baseline="300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</a:t>
                      </a:r>
                      <a:endParaRPr lang="ru-RU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D, 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N = 41</a:t>
                      </a:r>
                      <a:r>
                        <a:rPr lang="en-US" sz="1100" b="1" baseline="300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p-value</a:t>
                      </a:r>
                      <a:r>
                        <a:rPr lang="en-US" sz="1100" b="1" baseline="300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Observed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637.0 (566.0, 1,184.5)</a:t>
                      </a:r>
                      <a:endParaRPr lang="ru-RU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682.0 (556.0, 1,323.0)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256</a:t>
                      </a:r>
                      <a:endParaRPr lang="ru-RU" sz="110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Chao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790.6 (688.6, 1,344.1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808.5 (695.9, 1,408.6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363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se.chao1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6.9 (22.6, 32.5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2.5 (19.1, 28.7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008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A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791.3 (686.5, 1,313.7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808.7 (651.9, 1,405.2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35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se.AC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4.1 (13.2, 17.5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4.5 (12.7, 18.3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32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Shannon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3.9 (3.7, 4.3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4.1 (3.7, 4.6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156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Simpson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9 (0.9, 1.0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.0 (0.9, 1.0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38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InvSimpson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9.7 (14.6, 24.8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2.0 (14.3, 30.9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382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ishe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90.2 (79.0, 187.8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98.0 (77.4, 209.9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0.269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2750">
                <a:tc gridSpan="4"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ru-RU" sz="1100" baseline="300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1</a:t>
                      </a:r>
                      <a:r>
                        <a:rPr lang="ru-RU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Median (IQR)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</a:tr>
              <a:tr h="312750">
                <a:tc gridSpan="4"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500"/>
                        </a:spcAft>
                      </a:pP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2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Wilcoxon rank sum test; Wilcoxon rank sum exact test</a:t>
                      </a:r>
                      <a:endParaRPr lang="ru-RU" sz="1100" dirty="0">
                        <a:solidFill>
                          <a:schemeClr val="tx1"/>
                        </a:solidFill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784157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3. </a:t>
            </a:r>
            <a:r>
              <a:rPr lang="en-US" sz="1800" b="1" dirty="0"/>
              <a:t>Comparison of data obtained from two different methods of analysis (</a:t>
            </a:r>
            <a:r>
              <a:rPr lang="en-US" sz="1800" b="1" dirty="0" err="1"/>
              <a:t>LefSe</a:t>
            </a:r>
            <a:r>
              <a:rPr lang="en-US" sz="1800" b="1" dirty="0"/>
              <a:t> and MaaSlin2) </a:t>
            </a:r>
            <a:endParaRPr lang="ru-RU" sz="18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6786836"/>
              </p:ext>
            </p:extLst>
          </p:nvPr>
        </p:nvGraphicFramePr>
        <p:xfrm>
          <a:off x="539552" y="1268758"/>
          <a:ext cx="8208912" cy="3888433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8359"/>
                <a:gridCol w="925817"/>
                <a:gridCol w="792088"/>
                <a:gridCol w="658359"/>
                <a:gridCol w="658359"/>
                <a:gridCol w="918959"/>
                <a:gridCol w="658359"/>
                <a:gridCol w="1429873"/>
                <a:gridCol w="1508739"/>
              </a:tblGrid>
              <a:tr h="25230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</a:rPr>
                        <a:t>LefS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</a:rPr>
                        <a:t>enrich_group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</a:rPr>
                        <a:t>ef_lda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p-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>
                          <a:effectLst/>
                        </a:rPr>
                        <a:t>MaAslin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ru-RU" sz="1000" b="1" u="none" strike="noStrike" dirty="0">
                          <a:effectLst/>
                        </a:rPr>
                        <a:t> </a:t>
                      </a:r>
                      <a:endParaRPr lang="ru-RU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coef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>
                          <a:effectLst/>
                        </a:rPr>
                        <a:t>stderr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u="none" strike="noStrike" dirty="0" err="1">
                          <a:effectLst/>
                        </a:rPr>
                        <a:t>pvalue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7272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Normal contro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-2,710834802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0,00015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OTU20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 dirty="0">
                          <a:effectLst/>
                        </a:rPr>
                        <a:t>AD vs contro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 dirty="0">
                          <a:effectLst/>
                        </a:rPr>
                        <a:t>2,275867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 dirty="0">
                          <a:effectLst/>
                        </a:rPr>
                        <a:t>0,581956610624446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 dirty="0">
                          <a:effectLst/>
                        </a:rPr>
                        <a:t>0,000191872974181979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7272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Normal contro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-2,257040831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0,00193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AD vs cont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1,12889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305778587796202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000405130651818633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7272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Normal contro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-2,445163954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0,00336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AD vs cont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2,37339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651193309386514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000474348310813908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7272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Normal contro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-2,274674991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0,00041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2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AD vs cont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2,38288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657356977922158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000506522747840151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  <a:tr h="727226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Normal control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-3,657035405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ru-RU" sz="1000" u="none" strike="noStrike">
                          <a:effectLst/>
                        </a:rPr>
                        <a:t>0,00238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OTU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u="none" strike="noStrike">
                          <a:effectLst/>
                        </a:rPr>
                        <a:t>AD vs control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1,990779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>
                          <a:effectLst/>
                        </a:rPr>
                        <a:t>0,525510491900364</a:t>
                      </a:r>
                      <a:endParaRPr lang="ru-RU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ru-RU" sz="1000" u="none" strike="noStrike" dirty="0">
                          <a:effectLst/>
                        </a:rPr>
                        <a:t>0,000292387119129955</a:t>
                      </a:r>
                      <a:endParaRPr lang="ru-RU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07840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3568" y="116632"/>
            <a:ext cx="8013576" cy="1080120"/>
          </a:xfrm>
        </p:spPr>
        <p:txBody>
          <a:bodyPr>
            <a:noAutofit/>
          </a:bodyPr>
          <a:lstStyle/>
          <a:p>
            <a:pPr algn="l"/>
            <a:r>
              <a:rPr lang="en-US" sz="1800" b="1" dirty="0" smtClean="0"/>
              <a:t>Supplementary file Table </a:t>
            </a:r>
            <a:r>
              <a:rPr lang="en-US" sz="1800" b="1" dirty="0"/>
              <a:t>4</a:t>
            </a:r>
            <a:r>
              <a:rPr lang="en-US" sz="1800" b="1" dirty="0" smtClean="0"/>
              <a:t>. </a:t>
            </a:r>
            <a:r>
              <a:rPr lang="en-US" sz="1800" dirty="0" smtClean="0"/>
              <a:t>Correlation between gut microbiota community and disease severity.</a:t>
            </a:r>
            <a:endParaRPr lang="ru-RU" sz="1800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93624033"/>
              </p:ext>
            </p:extLst>
          </p:nvPr>
        </p:nvGraphicFramePr>
        <p:xfrm>
          <a:off x="611560" y="929523"/>
          <a:ext cx="7921253" cy="56205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5" name="Worksheet" r:id="rId4" imgW="9610645" imgH="6819771" progId="Excel.Sheet.12">
                  <p:embed/>
                </p:oleObj>
              </mc:Choice>
              <mc:Fallback>
                <p:oleObj name="Worksheet" r:id="rId4" imgW="9610645" imgH="6819771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11560" y="929523"/>
                        <a:ext cx="7921253" cy="56205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35070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1664</Words>
  <Application>Microsoft Office PowerPoint</Application>
  <PresentationFormat>On-screen Show (4:3)</PresentationFormat>
  <Paragraphs>400</Paragraphs>
  <Slides>7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9" baseType="lpstr">
      <vt:lpstr>Office Theme</vt:lpstr>
      <vt:lpstr>Worksheet</vt:lpstr>
      <vt:lpstr>   Supplementary file Figure 1. Principal coordinate analysis (PCoA) plot in different axis: a- PCoA1 (Axis 1) and PCoA2 (Axis 2) respectively explained 70.96 and 4.03% of the variance of the abundance of gut microbiota at the OTU level; b- PCoA1 (Axis 1) and PCoA3 (Axis 3) respectively explained 70.96 and 3.73% of the variance of the abundance of gut microbiota at the OTU level; c- PCoA2 (Axis 2) and PCoA3 (Axis 3) respectively explained 4.03 and 3.73% of the variance of the abundance of gut microbiota at the OTU level.</vt:lpstr>
      <vt:lpstr>Supplementary file Table 1a. Bacterial taxa in patients with a confirmed diagnosis versus controls at phylum level.</vt:lpstr>
      <vt:lpstr>Supplementary file Table 1b. Bacterial taxa in patients with a confirmed diagnosis versus controls at class level</vt:lpstr>
      <vt:lpstr>Supplementary file Table 1c. Bacterial taxa in patients with a confirmed diagnosis versus controls at genus level. </vt:lpstr>
      <vt:lpstr>Supplementary file Table 2. Analysis of α-diversity using Shannon, Simpson, Chao1, Observed, ACE, and Fisher indices</vt:lpstr>
      <vt:lpstr>Supplementary file Table 3. Comparison of data obtained from two different methods of analysis (LefSe and MaaSlin2) </vt:lpstr>
      <vt:lpstr>Supplementary file Table 4. Correlation between gut microbiota community and disease severity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. Principal coordinate analysis (PCoA) plot in different axis: a- PCoA1 (Axis 1) and PCoA2 (Axis 2) respectively explained 70.96 and 4.03% of the variance of the abundance of gut microbiota at the OTU level; b- PCoA1 (Axis 1) and PCoA3 (Axis 3) respectively explained 70.96 and 3.73% of the variance of the abundance of gut microbiota at the OTU level; c- PCoA2 (Axis 2) and PCoA3 (Axis 3) respectively explained 4.03 and 3.73% of the variance of the abundance of gut microbiota at the OTU level</dc:title>
  <dc:creator>Sholpan Askarova</dc:creator>
  <cp:lastModifiedBy>Sholpan Askarova</cp:lastModifiedBy>
  <cp:revision>15</cp:revision>
  <dcterms:created xsi:type="dcterms:W3CDTF">2022-06-29T10:27:44Z</dcterms:created>
  <dcterms:modified xsi:type="dcterms:W3CDTF">2022-09-02T05:59:59Z</dcterms:modified>
</cp:coreProperties>
</file>